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6C85A3-825C-4985-A56B-29214F12928A}" type="slidenum">
              <a:rPr b="0" lang="pl-PL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ymbol zastępczy numeru slajdu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AA3FE7-2481-4665-8E81-676A3EDF99F3}" type="slidenum">
              <a:rPr b="0" lang="pl-PL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ymbol zastępczy numeru slajdu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A94FBB-8359-4498-ABD5-B29BC45EDD0A}" type="slidenum">
              <a:rPr b="0" lang="pl-PL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6700D-7AA6-46ED-8681-A77FBC9A02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44534-13FE-4A7D-AC4D-0C18058E7F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DEFB4-C814-474F-9D53-B10E42632D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6325F-AFDA-48D2-98BF-2146331011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40F93-F5B8-47FD-977D-98DDC6BE97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9CD19-D533-45C3-A811-BAA24C87D0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7B462-C08C-4FF5-AFDD-C67E3F8F56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9C07B-2B56-4E27-AB99-43D2297CB8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7A96F-185D-4035-9815-501A09C411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A2441-59EE-47D7-84B4-2EB3C35A23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7DB36-9859-4CEB-BB5D-5AACC22874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74FDE-DBE9-4037-8949-A9051D6557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D51B1E-743D-4054-9A9B-17B41972A770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 txBox="1"/>
          <p:nvPr/>
        </p:nvSpPr>
        <p:spPr>
          <a:xfrm>
            <a:off x="0" y="71280"/>
            <a:ext cx="6858000" cy="9144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8000"/>
          </a:bodyPr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Calc. Mass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Obsrv. Mass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±da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±ppm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Start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End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Sequence                          Ion 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C.I. %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Modification  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Rank                    PROTEIN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   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Seq.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Seq.                                      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Score                                                          </a:t>
            </a:r>
            <a:r>
              <a:rPr b="1" lang="en-CA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Result Typ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262.7328  1262.7382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05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1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2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RPLNTAPIQPR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6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8.84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262.7328   1262.7382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 0.005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1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2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RPLNTAPIQP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sRAG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18.8339   1418.8389        0.00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21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2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RRPLNTAPIQP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5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        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18.8339   1418.8389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 0.00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21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2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RRPLNTAPIQP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89.4101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89.4146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4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SVDEALR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7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76.5189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76.509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9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1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8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GLFIIDAK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37.437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37.437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12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2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NDEGIAY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7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9.72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37.437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937.437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2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2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NDEGIAY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76.48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976.414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-0.073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-7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GNAQIGK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8.599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8.588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12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1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SLSQNYGVLK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9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9.965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8.599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8.588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12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1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0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SLSQNYGVLK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11.6743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11.6732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1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0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0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QITVNDLPVGR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3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9.983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             Peroxiredoxin I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11.6743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11.673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11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0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50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QITVNDLPVGR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06.9688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06.954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4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8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3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EGGLGPLNIPLLADVTK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2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0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06.9688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06.9543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45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8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3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EGGLGPLNIPLLADVTK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35.063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35.055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08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4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KEGGLGPLNIPLLADVTK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0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35.063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35.055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8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4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KEGGLGPLNIPLLADVTK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699.3611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699.3755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144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5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8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L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GCEVLGVSVDSQFTHL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Carbamidomethyl (C)[3]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      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758.415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758.414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-0.001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-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7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7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 VNADAL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819.399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819.398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00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0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06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 ETDWL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49.446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49.4454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11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VVAEEFR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46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.162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49.446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49.445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1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1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VVAEEFR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45.557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45.56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10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7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7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  MRVNADAL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16.514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1116.515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0.001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8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9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FGLYSDQM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16.514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16.5154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0.001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8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9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 FGLYSDQM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32.509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32.501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075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8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9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 FGLYSDQM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   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Oxidation (M)[8]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32.509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32.501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075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18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9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     FGLYSDQM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Oxidation (M)[8]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95.537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195.546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0.00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3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3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WNEEVEAY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Apolipoprotein A-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227.625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227.606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18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1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36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46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DFATVYVDAV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52.695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352.685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06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8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0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NHPTLIEYHTK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7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9.93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52.695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352.685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10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8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0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NHPTLIEYHTK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92.784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92.767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172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2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QKLEPLGTELHK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17.641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417.635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61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4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0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QPHLDEFQEK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48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48.523                          Oxidation (M)[1]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17.6417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17.635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6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4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0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QPHLDEFQEK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Oxidation (M)[1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4.7891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454.782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06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5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4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4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VKDFATVYVDAVK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60.6904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60.6851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53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4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51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3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DYVSQFESSTLGK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29.0986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129.1042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56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4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QLNLNLLDNWDTLGSTVG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53.4301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53.461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.031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7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27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3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YEATLEK      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4.503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4.517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.014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11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319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CTLPEAQR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1,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36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17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1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5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7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FPNAEFAEITK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699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063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5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2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HPDYSVSLLLR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1439.788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0.0035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8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30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1439.788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   0.003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28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30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799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76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11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22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RHPDYSVSLLLR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799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76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5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11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2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RHPDYSVSLLLR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795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7974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19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7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84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LGEYGFQNAILVR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Mascot           Albumin CRA_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941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43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98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10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DVFLGTFLYEYSR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0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609.794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.0043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8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210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DVFLGTFLYEYSR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06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2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33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LPCVEDYLSAILNR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Carbamidomethyl (C)[3]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7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00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320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33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LPCVEDYLSAILNR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Carbamidomethyl (C)[3]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9.662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9.6741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.011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7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8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1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ECCHGDLLECADDR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Carbamidomethyl (C)[2,3,10]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25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 0.0043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2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59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37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RPCFSALTVDETYVPK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0                Carbamidomethyl (C)[3]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2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043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2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59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7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RPCFSALTVDETYVPK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3]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12.3737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12.369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0.0038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5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9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SEIAHR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0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973.4738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973.4733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005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37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44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DLGEQHFK  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17.536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017.5275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08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9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9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9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SIHTLFGDK   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5.4878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5.486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16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1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58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PYEEHIK 39 0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Carbamidomethyl (C)[1]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5.487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075.4862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016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1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58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5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PYEEHIK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1]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49.615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49.606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9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8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66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75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LVQEVTDFAK 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37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296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-0.0076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6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35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4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FKDLGEQHFK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80         99.971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Mascot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Album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372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296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076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6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35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44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FKDLGEQHFK     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15.556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15.5582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0.001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6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1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DNYGELADCCAK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9,10]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857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8452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11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8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45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57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GLVLIAFSQYLQK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94         99.999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8571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8452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-0.0119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-8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45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57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GLVLIAFSQYLQK                                                 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84.7418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1684.7515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.009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6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4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LRDNYGELADCCAK               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11,12]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35880" indent="-3358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14.7966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14.8033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0.0067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4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8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0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QEPERNECFLQHK      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0  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99.975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Carbamidomethyl (C)[8]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CA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Łącznik prosty 4"/>
          <p:cNvSpPr/>
          <p:nvPr/>
        </p:nvSpPr>
        <p:spPr>
          <a:xfrm>
            <a:off x="0" y="21420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Łącznik prosty 5"/>
          <p:cNvSpPr/>
          <p:nvPr/>
        </p:nvSpPr>
        <p:spPr>
          <a:xfrm>
            <a:off x="0" y="46836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Nawias klamrowy zamykający 6"/>
          <p:cNvSpPr/>
          <p:nvPr/>
        </p:nvSpPr>
        <p:spPr>
          <a:xfrm>
            <a:off x="5929200" y="1081080"/>
            <a:ext cx="142920" cy="17049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704960"/>
              <a:gd name="textAreaBottom" fmla="*/ 1701360 h 1704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6"/>
                  <a:pt x="10800" y="151"/>
                </a:cubicBezTo>
                <a:lnTo>
                  <a:pt x="10800" y="10649"/>
                </a:lnTo>
                <a:cubicBezTo>
                  <a:pt x="10800" y="10725"/>
                  <a:pt x="16200" y="10800"/>
                  <a:pt x="21600" y="10800"/>
                </a:cubicBezTo>
                <a:cubicBezTo>
                  <a:pt x="16200" y="10800"/>
                  <a:pt x="10800" y="10876"/>
                  <a:pt x="10800" y="10951"/>
                </a:cubicBezTo>
                <a:lnTo>
                  <a:pt x="10800" y="21449"/>
                </a:lnTo>
                <a:cubicBezTo>
                  <a:pt x="10800" y="21525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Nawias klamrowy zamykający 7"/>
          <p:cNvSpPr/>
          <p:nvPr/>
        </p:nvSpPr>
        <p:spPr>
          <a:xfrm>
            <a:off x="5929200" y="3071880"/>
            <a:ext cx="142920" cy="22143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214360"/>
              <a:gd name="textAreaBottom" fmla="*/ 2210760 h 221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8"/>
                  <a:pt x="10800" y="116"/>
                </a:cubicBezTo>
                <a:lnTo>
                  <a:pt x="10800" y="10684"/>
                </a:lnTo>
                <a:cubicBezTo>
                  <a:pt x="10800" y="10742"/>
                  <a:pt x="16200" y="10800"/>
                  <a:pt x="21600" y="10800"/>
                </a:cubicBezTo>
                <a:cubicBezTo>
                  <a:pt x="16200" y="10800"/>
                  <a:pt x="10800" y="10858"/>
                  <a:pt x="10800" y="10916"/>
                </a:cubicBezTo>
                <a:lnTo>
                  <a:pt x="10800" y="21484"/>
                </a:lnTo>
                <a:cubicBezTo>
                  <a:pt x="10800" y="21542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Nawias klamrowy zamykający 8"/>
          <p:cNvSpPr/>
          <p:nvPr/>
        </p:nvSpPr>
        <p:spPr>
          <a:xfrm>
            <a:off x="5929200" y="5500800"/>
            <a:ext cx="142920" cy="192888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928880"/>
              <a:gd name="textAreaBottom" fmla="*/ 1925280 h 1928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7"/>
                  <a:pt x="10800" y="133"/>
                </a:cubicBezTo>
                <a:lnTo>
                  <a:pt x="10800" y="10667"/>
                </a:lnTo>
                <a:cubicBezTo>
                  <a:pt x="10800" y="10734"/>
                  <a:pt x="16200" y="10800"/>
                  <a:pt x="21600" y="10800"/>
                </a:cubicBezTo>
                <a:cubicBezTo>
                  <a:pt x="16200" y="10800"/>
                  <a:pt x="10800" y="10867"/>
                  <a:pt x="10800" y="10933"/>
                </a:cubicBezTo>
                <a:lnTo>
                  <a:pt x="10800" y="21467"/>
                </a:lnTo>
                <a:cubicBezTo>
                  <a:pt x="10800" y="21534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Nawias klamrowy zamykający 9"/>
          <p:cNvSpPr/>
          <p:nvPr/>
        </p:nvSpPr>
        <p:spPr>
          <a:xfrm>
            <a:off x="5929200" y="500040"/>
            <a:ext cx="142920" cy="500040"/>
          </a:xfrm>
          <a:custGeom>
            <a:avLst/>
            <a:gdLst>
              <a:gd name="textAreaLeft" fmla="*/ 0 w 142920"/>
              <a:gd name="textAreaRight" fmla="*/ 51480 w 142920"/>
              <a:gd name="textAreaTop" fmla="*/ 3600 h 500040"/>
              <a:gd name="textAreaBottom" fmla="*/ 496440 h 500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57"/>
                  <a:pt x="10800" y="514"/>
                </a:cubicBezTo>
                <a:lnTo>
                  <a:pt x="10800" y="10286"/>
                </a:lnTo>
                <a:cubicBezTo>
                  <a:pt x="10800" y="10543"/>
                  <a:pt x="16200" y="10800"/>
                  <a:pt x="21600" y="10800"/>
                </a:cubicBezTo>
                <a:cubicBezTo>
                  <a:pt x="16200" y="10800"/>
                  <a:pt x="10800" y="11057"/>
                  <a:pt x="10800" y="11314"/>
                </a:cubicBezTo>
                <a:lnTo>
                  <a:pt x="10800" y="21086"/>
                </a:lnTo>
                <a:cubicBezTo>
                  <a:pt x="10800" y="2134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Nawias klamrowy zamykający 10"/>
          <p:cNvSpPr/>
          <p:nvPr/>
        </p:nvSpPr>
        <p:spPr>
          <a:xfrm>
            <a:off x="5929200" y="7572240"/>
            <a:ext cx="142920" cy="15717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571760"/>
              <a:gd name="textAreaBottom" fmla="*/ 1568160 h 15717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82"/>
                  <a:pt x="10800" y="164"/>
                </a:cubicBezTo>
                <a:lnTo>
                  <a:pt x="10800" y="10636"/>
                </a:lnTo>
                <a:cubicBezTo>
                  <a:pt x="10800" y="10718"/>
                  <a:pt x="16200" y="10800"/>
                  <a:pt x="21600" y="10800"/>
                </a:cubicBezTo>
                <a:cubicBezTo>
                  <a:pt x="16200" y="10800"/>
                  <a:pt x="10800" y="10882"/>
                  <a:pt x="10800" y="10964"/>
                </a:cubicBezTo>
                <a:lnTo>
                  <a:pt x="10800" y="21436"/>
                </a:lnTo>
                <a:cubicBezTo>
                  <a:pt x="10800" y="2151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ole tekstowe 11"/>
          <p:cNvSpPr/>
          <p:nvPr/>
        </p:nvSpPr>
        <p:spPr>
          <a:xfrm>
            <a:off x="1800" y="-47520"/>
            <a:ext cx="472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Table S1</a:t>
            </a:r>
            <a:r>
              <a:rPr b="1" lang="pl-PL" sz="1100" spc="-1" strike="noStrike">
                <a:solidFill>
                  <a:srgbClr val="000000"/>
                </a:solidFill>
                <a:latin typeface="Calibri"/>
              </a:rPr>
              <a:t>. Structural information of the peptides used for protein identifica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 txBox="1"/>
          <p:nvPr/>
        </p:nvSpPr>
        <p:spPr>
          <a:xfrm>
            <a:off x="0" y="0"/>
            <a:ext cx="6858000" cy="9144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Calc.            Obsrv.          ±da   ±ppm  Start   End   Sequence                                     Ion             C.I. %                        Modification               Rank                    PROTEIN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Mass            Mass                                 Seq.    Seq.                                                     Score                                                                               Result Typ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53.4301    853.4677     0.0376   44        377      383    YEATLEK         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53.4301    853.4677     0.0376   44        377      383    YEATLEK         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372   1248.6429     0.0057     5          35        44    FKDLGEQHFK 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365   1266.6216   -0.0149  -12         247      257    FPNAEFAEITK                           100           100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365   1266.6216   -0.0149  -12         247      257    FPNAEFAEITK 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1299.7017   -0.0039    -3         362      372    HPDYSVSLLLR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1299.7017   -0.0039    -3         362      372    HPDYSVSLLLR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47.6193   1447.6052   -0.0141  -10         287      298    YMCENQATISSK                                             Carbamidomethyl (C)[3], Oxidation (M)[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9.7396   1459.7273   -0.0123    -8         299      310    LQACCDKPVLQK                                                                    Carbamidomethyl (C)[4,5]     Mascot          Unnamed prote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1609.7964    0.0066     4         348      360    DVFLGTFLYEYSR                     121            100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1609.7964    0.0066     4         348      360    DVFLGTFLYEYSR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6.731     1746.7241   -0.0069    -4         185      198    YNEVLTQCCTESDK                                                                Carbamidomethyl (C)[8,9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9.6626   1749.6685    0.0059     3         268      281    ECCHGDLLECADDR                 102            100                 Carbamidomethyl (C)[2,3,10]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9.6626   1749.6685    0.0059     3         268      281    ECCHGDLLECADDR                                                          Carbamidomethyl (C)[2,3,10]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261.9585   2261.9624    0.0039     2         268      286    ECCHGDLLECADDRAEL          125            100                  Carbamidomethyl (C)[2,3,10]      Mascot                   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261.9585   2261.9624    0.0039     2         268      286    ECCHGDLLECADDRAEL          125            100                  Carbamidomethyl (C)[2,3,10]      Mascot                   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985.3782   2985.3687   -0.0095    -3         311      337   SQCLAETEHDNIPADLPSI                                                           C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AADFVEDK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53.4301     853.4749     0.0448   52         377      383    YEATLEK        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98.4815     898.4785    -0.003     -3         484       490    LCVLHEK                                                                                   Carbamidomethyl (C)[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56.4667   1056.4695     0.0028    3         414        421   TNCELYEK                                                                                 C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67.4609   1067.4706     0.0097    9         500        508   CCSGSLVER                                                                           Carbamidomethyl (C)[1,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4.5031   1134.5103     0.0072    6         461        469   CCTLPEAQR                                                                           Carbamidomethyl (C)[1,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372   1248.6428     0.0056    4           35          44   FKDLGEQHFK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365   1266.6302    -0.0063   -5         247        257   FPNAEFAEITK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1299.7096     0.004      3         362        372   HPDYSVSLLLR                         102            100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1299.7096     0.004      3         362        372   HPDYSVSLLLR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357.645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357.641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-0.004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-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57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 58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 TVMGDFAQFVD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73.6406   1373.6313    -0.0093  -7          570        581   TVMGDFAQFVDK                                                                                  Oxidation (M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800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15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3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5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1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800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15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3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5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47.6193   1447.6295     0.0102    7         287        298   YMCENQATISSK                                             Carbamidomethyl (C)[3], Oxidation (M)[2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1455.8135     0.0069    5         361        372   RHPDYSVSLLLR                        55              92.696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1455.8135     0.0069    5         361        372   RHPDYSVSLLLR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9.7396   1459.756       0.0164  11         299        310  LQACCDKPVLQK                                                                     Carbamidomethyl (C)[4,5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65.7798   1465.7875     0.0077    5         422       434   LGEYGFQNAVLVR                     113             100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65.7798   1465.7875     0.0077    5         422       434   LGEYGFQNAVLVR                                                                                                                Mascot              Serum album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479.857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479.797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594 -4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4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5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GLVLIAFSQYLQ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479.857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479.797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594 -4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4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5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GLVLIAFSQYLQ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63.722     1563.7296     0.0076     5        589       602  DNCFATEGPNLVAR                                                                    C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1609.8008     0.011       7        348       360  DVFLGTFLYEYSR                      105             100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1609.8008     0.011       7        348       360  DVFLGTFLYEYSR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1662.8617     0.0096     6        470      483   LPCVEDYLSAILNR                     134             100                         C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1662.8617     0.0096     6        470      483   LPCVEDYLSAILNR                                                                       Carbamidomethyl (C)[3]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6.731     1746.7322     0.0012    1         185      198   YNEVLTQCCTESDK                                                                  Carbamidomethyl (C)[8,9]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49.6626   1749.6779     0.0153    9         268      281   ECCHGDLLECADDR                                                            Carbamidomethyl (C)[2,3,10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1.8688   1881.8944     0.0256  14         528      543   AETFTFHSDICTLPDK                                                                Carbamidomethyl (C)[11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1882.9515     0.0147   8          509      524   RPCFSALTVDETYVPK                 49              64.877                   C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1882.9515     0.0147   8          509      524   RPCFSALTVDETYVPK                                                                C arbamidomethyl (C)[3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48.9182   1948.9272     0.009     5          585      602   AADKDNCFATEGPNLVAR         165             100                         Carbamidomethyl (C)[7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48.9182   1948.9272     0.009     5          585      602   AADKDNCFATEGPNLVAR         165             100                         Carbamidomethyl (C)[7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39.0063   2139.0139     0.0076    4         528      545   AETFTFHSDICTLPDKEK              83              99.989                 Carbamidomethyl (C)[11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39.0063   2139.0139     0.0076    4         528      545   AETFTFHSDICTLPDKEK                                                            Carbamidomethyl (C)[11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261.9585   2261.9705     0.012      5         268      286   ECCHGDLLECADDRAELAK                                                 Carbamidomethyl (C)[2,3,10] 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937.3103   2937.3152     0.0049    2         384      409   CCAEGDPPACYGTVLAE                                                      Carbamidomethyl (C)[1,2,10]    Masc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FQPLVEEPK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Łącznik prosty 4"/>
          <p:cNvSpPr/>
          <p:nvPr/>
        </p:nvSpPr>
        <p:spPr>
          <a:xfrm>
            <a:off x="0" y="14292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Łącznik prosty 5"/>
          <p:cNvSpPr/>
          <p:nvPr/>
        </p:nvSpPr>
        <p:spPr>
          <a:xfrm>
            <a:off x="0" y="42876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Nawias klamrowy zamykający 6"/>
          <p:cNvSpPr/>
          <p:nvPr/>
        </p:nvSpPr>
        <p:spPr>
          <a:xfrm>
            <a:off x="5929200" y="2857680"/>
            <a:ext cx="214560" cy="5500440"/>
          </a:xfrm>
          <a:custGeom>
            <a:avLst/>
            <a:gdLst>
              <a:gd name="textAreaLeft" fmla="*/ 0 w 214560"/>
              <a:gd name="textAreaRight" fmla="*/ 77400 w 214560"/>
              <a:gd name="textAreaTop" fmla="*/ 5400 h 5500440"/>
              <a:gd name="textAreaBottom" fmla="*/ 5495040 h 5500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5"/>
                  <a:pt x="10800" y="70"/>
                </a:cubicBezTo>
                <a:lnTo>
                  <a:pt x="10800" y="10730"/>
                </a:lnTo>
                <a:cubicBezTo>
                  <a:pt x="10800" y="10765"/>
                  <a:pt x="16200" y="10800"/>
                  <a:pt x="21600" y="10800"/>
                </a:cubicBezTo>
                <a:cubicBezTo>
                  <a:pt x="16200" y="10800"/>
                  <a:pt x="10800" y="10835"/>
                  <a:pt x="10800" y="10870"/>
                </a:cubicBezTo>
                <a:lnTo>
                  <a:pt x="10800" y="21530"/>
                </a:lnTo>
                <a:cubicBezTo>
                  <a:pt x="10800" y="21565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Nawias klamrowy zamykający 7"/>
          <p:cNvSpPr/>
          <p:nvPr/>
        </p:nvSpPr>
        <p:spPr>
          <a:xfrm>
            <a:off x="5929200" y="581040"/>
            <a:ext cx="142920" cy="206208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062080"/>
              <a:gd name="textAreaBottom" fmla="*/ 2058480 h 2062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3"/>
                  <a:pt x="10800" y="125"/>
                </a:cubicBezTo>
                <a:lnTo>
                  <a:pt x="10800" y="10675"/>
                </a:lnTo>
                <a:cubicBezTo>
                  <a:pt x="10800" y="10738"/>
                  <a:pt x="16200" y="10800"/>
                  <a:pt x="21600" y="10800"/>
                </a:cubicBezTo>
                <a:cubicBezTo>
                  <a:pt x="16200" y="10800"/>
                  <a:pt x="10800" y="10863"/>
                  <a:pt x="10800" y="10925"/>
                </a:cubicBezTo>
                <a:lnTo>
                  <a:pt x="10800" y="21475"/>
                </a:lnTo>
                <a:cubicBezTo>
                  <a:pt x="10800" y="2153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"/>
          <p:cNvSpPr txBox="1"/>
          <p:nvPr/>
        </p:nvSpPr>
        <p:spPr>
          <a:xfrm>
            <a:off x="0" y="142560"/>
            <a:ext cx="68580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marL="341280" indent="-3412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marL="341280" indent="-34128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Łącznik prosty 3"/>
          <p:cNvSpPr/>
          <p:nvPr/>
        </p:nvSpPr>
        <p:spPr>
          <a:xfrm>
            <a:off x="0" y="7128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Łącznik prosty 4"/>
          <p:cNvSpPr/>
          <p:nvPr/>
        </p:nvSpPr>
        <p:spPr>
          <a:xfrm>
            <a:off x="0" y="500040"/>
            <a:ext cx="685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rostokąt 5"/>
          <p:cNvSpPr/>
          <p:nvPr/>
        </p:nvSpPr>
        <p:spPr>
          <a:xfrm>
            <a:off x="0" y="71280"/>
            <a:ext cx="68580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9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pl-PL" sz="900" spc="-1" strike="noStrike">
                <a:solidFill>
                  <a:srgbClr val="000000"/>
                </a:solidFill>
                <a:latin typeface="Arial Narrow"/>
              </a:rPr>
              <a:t>Calc.            Obsrv.          ±da   ±ppm   Start     End      Sequence                     Ion       C.I. %                   Modification              Rank                    PROTEIN                                                          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9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1" lang="pl-PL" sz="900" spc="-1" strike="noStrike">
                <a:solidFill>
                  <a:srgbClr val="000000"/>
                </a:solidFill>
                <a:latin typeface="Arial Narrow"/>
              </a:rPr>
              <a:t>Mass            Mass                                  Seq.      Seq.                                          Score                                                                     Result Typ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ole tekstowe 9"/>
          <p:cNvSpPr/>
          <p:nvPr/>
        </p:nvSpPr>
        <p:spPr>
          <a:xfrm>
            <a:off x="785880" y="1000080"/>
            <a:ext cx="183960" cy="23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rostokąt 10"/>
          <p:cNvSpPr/>
          <p:nvPr/>
        </p:nvSpPr>
        <p:spPr>
          <a:xfrm>
            <a:off x="0" y="598320"/>
            <a:ext cx="6858000" cy="678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804.409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804.404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05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56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569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ATEDQL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898.4815      898.4738        -0.0077       -9       484      490   LCVLHEK                                                                            Carbamidomethyl (C)[2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981.525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981.515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 -0.0098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 -1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37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38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KYEATLEK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nn-NO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56.4667    1056.4628        -0.0039       -4       414      421   TNCELYEK                                                                          Carbamidomethyl (C)[3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67.4609    1067.4697         0.0088        8       500      508   CCSGSLVER                                                                    Carbamidomethyl (C)[1,2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5.4878    1075.4874        -0.0004        0         58        65   CPYEEHIK                                                                          Carbamidomethyl (C)[1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4.5031    1134.5031         0                 0       461     469    CCTLPEAQR                         37          0                           Carbamidomethyl (C)[1,2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4.5031    1134.5031         0                 0       461     469    CCTLPEAQR                                                                   Carbamidomethyl (C)[1,2]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48.6372    1248.6216        -0.0156     -12         35       44    FKDLGEQHFK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66.6365    1266.6219        -0.0146     -12       247     257    FPNAEFAEITK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 1299.7053        -0.0003        0       362     372    HPDYSVSLLLR                      52        84.217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299.7056    1299.7053        -0.0003        0       362     372    HPDYSVSLLLR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357.645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357.641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-0.0042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 -3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57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58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TVMGDFAQFVD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373.6406    1373.6189        -0.0217       -1       570     581    TVMGDFAQFVDK                                                                          Oxidation (M)[3]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9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077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3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45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00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85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1439.793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0.007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439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 452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APQVSTPTLVEAA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</a:t>
            </a:r>
            <a:r>
              <a:rPr b="0" lang="pt-BR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 1455.8038        -0.0028       -2       361     372    RHPDYSVSLLLR                   44         0                                                                           Mascot     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Albu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55.8066    1455.8038        -0.0028       -2       361     372    RHPDYSVSLLLR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7955    1479.7953        -0.0002        0       422     434    LGEYGFQNAILVR                 75        99.846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479.7955    1479.7953        -0.0002        0       422     434    LGEYGFQNAILVR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563.722      1563.7234         0.0014        1       589     602    DNCFATEGPNLVAR                                                          Carbamidomethyl (C)[3]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 1609.7947         0.0049        3       348     360    DVFLGTFLYEYSR                 88       99.993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09.7898    1609.7947         0.0049        3       348     360    DVFLGTFLYEYSR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 1662.8551         0.003          2       470     483    LPCVEDYLSAILNR                95       99.999                        Carbamidomethyl (C)[3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62.8521    1662.8551         0.003          2       470     483    LPCVEDYLSAILNR                                                             Carbamidomethyl (C)[3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14.7966    1714.7948        -0.0018       -1       118     130    QEPERNECFLQHK                                                            Carbamidomethyl (C)[8]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1.8688    1881.8726         0.0038        2       528     543    AETFTFHSDICTLPDK                                                       Carbamidomethyl (C)[11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 1882.9404         0.0036        2       509     524    RPCFSALTVDETYVPK          68       99.259                        Carbamidomethyl (C)[3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882.9368    1882.9404         0.0036        2       509     524    RPCFSALTVDETYVPK                                                       Carbamidomethyl (C)[3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48.9182    1948.9225         0.0043        2       585     602    AADKDNCFATEGPNLVAR  139     100                               Carbamidomethyl (C)[7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48.9182    1948.9225         0.0043        2       585     602    AADKDNCFATEGPNLVAR  139     100                               Carbamidomethyl (C)[7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139.0063    2139.0105         0.0042        2       528     545    AETFTFHSDICTLPDKEK                                                  Carbamidomethyl (C)[11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937.3103    2937.3235         0.0132        4       384     409    CCAEGDPPACYGTVLAE                                            Carbamidomethyl (C)[1,2,10]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FQPLVEEP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7.5323    1077.5284        -0.0039    -4             113    120  IREEYPDR                            13         0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077.5323    1077.5284       -0.0039     -4             113    120  IREEYPDR      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0.5953    1130.6014        0.0061      5              200   209  FPGQLNADLR                      74       99.843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30.5953    1130.6014        0.0061      5              200   209  FPGQLNADLR        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143.634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1143.629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-0.0048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-4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211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 220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 LAVNMVPFPR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    </a:t>
            </a:r>
            <a:r>
              <a:rPr b="0" lang="da-DK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59.6293    1159.6244       -0.0049    -4               211   220  LAVNMVPFPR                                                                                Oxidation (M)[5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159.6293    1159.6244       -0.0049    -4               211   220  LAVNMVPFPR                                                                                Oxidation (M)[5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328.6481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1328.6385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0.009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-7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5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 16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INVYYNEATGGK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            </a:t>
            </a:r>
            <a:r>
              <a:rPr b="0" lang="en-US" sz="800" spc="-1" strike="noStrike">
                <a:solidFill>
                  <a:srgbClr val="000000"/>
                </a:solidFill>
                <a:latin typeface="Arial Narrow"/>
              </a:rPr>
              <a:t>Mascot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</a:t>
            </a:r>
            <a:r>
              <a:rPr b="1" lang="pl-PL" sz="800" spc="-1" strike="noStrike">
                <a:solidFill>
                  <a:srgbClr val="000000"/>
                </a:solidFill>
                <a:latin typeface="Arial Narrow"/>
              </a:rPr>
              <a:t>Unnamed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20.8356    1620.8408        0.0052     3               221   234  LHFFMPGFAPLTSR                                                                                                 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36.8304    1636.8313        0.0009     1               221   234  LHFFMPGFAPLTSR              9           0                                           Oxidation (M)[5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636.8304    1636.8313        0.0009     1               221   234  LHFFMPGFAPLTSR                                                                        Oxidation (M)[5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707.8622    1707.8293       -0.0329  -19               241   255  ALTVPELTQQMFDAK                                                                   Oxidation (M)[11]       Masc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58.9818    1958.9952        0.0134     7                 62     79  GHYTEGAELVDSVLDVVR 62          97.523                                                                    Mascot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1958.9818    1958.9952        0.0134     7                 62     79  GHYTEGAELVDSVLDVVR 62          97.523                                                                    Mascot                                                    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2724.3333    2724.3403        0.007       3               175   199  LTTPTYGDLNHLVSATMS                    Carbamidomethyl (C)[23], Oxidation (M)[17]      Mascot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                                                                                               </a:t>
            </a:r>
            <a:r>
              <a:rPr b="0" lang="pl-PL" sz="800" spc="-1" strike="noStrike">
                <a:solidFill>
                  <a:srgbClr val="000000"/>
                </a:solidFill>
                <a:latin typeface="Arial Narrow"/>
              </a:rPr>
              <a:t>GVTTCL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Nawias klamrowy zamykający 7"/>
          <p:cNvSpPr/>
          <p:nvPr/>
        </p:nvSpPr>
        <p:spPr>
          <a:xfrm>
            <a:off x="5929200" y="642960"/>
            <a:ext cx="142920" cy="40719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4071960"/>
              <a:gd name="textAreaBottom" fmla="*/ 4068360 h 4071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2"/>
                  <a:pt x="10800" y="63"/>
                </a:cubicBezTo>
                <a:lnTo>
                  <a:pt x="10800" y="10737"/>
                </a:lnTo>
                <a:cubicBezTo>
                  <a:pt x="10800" y="10769"/>
                  <a:pt x="16200" y="10800"/>
                  <a:pt x="21600" y="10800"/>
                </a:cubicBezTo>
                <a:cubicBezTo>
                  <a:pt x="16200" y="10800"/>
                  <a:pt x="10800" y="10832"/>
                  <a:pt x="10800" y="10863"/>
                </a:cubicBezTo>
                <a:lnTo>
                  <a:pt x="10800" y="21537"/>
                </a:lnTo>
                <a:cubicBezTo>
                  <a:pt x="10800" y="21569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Nawias klamrowy zamykający 8"/>
          <p:cNvSpPr/>
          <p:nvPr/>
        </p:nvSpPr>
        <p:spPr>
          <a:xfrm>
            <a:off x="5929200" y="4867200"/>
            <a:ext cx="142920" cy="191952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919520"/>
              <a:gd name="textAreaBottom" fmla="*/ 1915920 h 1919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7"/>
                  <a:pt x="10800" y="134"/>
                </a:cubicBezTo>
                <a:lnTo>
                  <a:pt x="10800" y="10666"/>
                </a:lnTo>
                <a:cubicBezTo>
                  <a:pt x="10800" y="10733"/>
                  <a:pt x="16200" y="10800"/>
                  <a:pt x="21600" y="10800"/>
                </a:cubicBezTo>
                <a:cubicBezTo>
                  <a:pt x="16200" y="10800"/>
                  <a:pt x="10800" y="10867"/>
                  <a:pt x="10800" y="10934"/>
                </a:cubicBezTo>
                <a:lnTo>
                  <a:pt x="10800" y="21466"/>
                </a:lnTo>
                <a:cubicBezTo>
                  <a:pt x="10800" y="2153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4T22:10:07Z</dcterms:created>
  <dc:creator>Adrian</dc:creator>
  <dc:description/>
  <dc:language>en-US</dc:language>
  <cp:lastModifiedBy>BMC</cp:lastModifiedBy>
  <dcterms:modified xsi:type="dcterms:W3CDTF">2010-01-27T16:01:48Z</dcterms:modified>
  <cp:revision>4</cp:revision>
  <dc:subject/>
  <dc:title>Slajd 1</dc:title>
</cp:coreProperties>
</file>